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070" autoAdjust="0"/>
  </p:normalViewPr>
  <p:slideViewPr>
    <p:cSldViewPr snapToGrid="0">
      <p:cViewPr varScale="1">
        <p:scale>
          <a:sx n="61" d="100"/>
          <a:sy n="61" d="100"/>
        </p:scale>
        <p:origin x="349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995312"/>
            <a:ext cx="5143500" cy="4244622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C3414-48B5-4E65-81B7-31FB95F059CD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996FC-EA2A-41C4-B4BA-EC677700DF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33251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C3414-48B5-4E65-81B7-31FB95F059CD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996FC-EA2A-41C4-B4BA-EC677700DF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4225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6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7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C3414-48B5-4E65-81B7-31FB95F059CD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996FC-EA2A-41C4-B4BA-EC677700DF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80420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C3414-48B5-4E65-81B7-31FB95F059CD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996FC-EA2A-41C4-B4BA-EC677700DF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58606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5"/>
            <a:ext cx="5915025" cy="5071532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6"/>
            <a:ext cx="5915025" cy="266699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C3414-48B5-4E65-81B7-31FB95F059CD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996FC-EA2A-41C4-B4BA-EC677700DF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88011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C3414-48B5-4E65-81B7-31FB95F059CD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996FC-EA2A-41C4-B4BA-EC677700DF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9934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2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C3414-48B5-4E65-81B7-31FB95F059CD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996FC-EA2A-41C4-B4BA-EC677700DF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86976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C3414-48B5-4E65-81B7-31FB95F059CD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996FC-EA2A-41C4-B4BA-EC677700DF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81297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C3414-48B5-4E65-81B7-31FB95F059CD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996FC-EA2A-41C4-B4BA-EC677700DF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16219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3" cy="28448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3"/>
            <a:ext cx="3471863" cy="8664222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3" cy="6776156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C3414-48B5-4E65-81B7-31FB95F059CD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996FC-EA2A-41C4-B4BA-EC677700DF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18806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3" cy="28448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5543" y="1755423"/>
            <a:ext cx="3471863" cy="8664222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3" cy="6776156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C3414-48B5-4E65-81B7-31FB95F059CD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996FC-EA2A-41C4-B4BA-EC677700DF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61260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2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79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CC3414-48B5-4E65-81B7-31FB95F059CD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79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79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3996FC-EA2A-41C4-B4BA-EC677700DF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20495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5464" y="1107415"/>
            <a:ext cx="5021451" cy="773653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5464" y="8900369"/>
            <a:ext cx="5625885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Dose-dependent mouse model of </a:t>
            </a:r>
            <a:r>
              <a:rPr lang="en-US" sz="1600" b="1" i="1" dirty="0">
                <a:latin typeface="Arial" panose="020B0604020202020204" pitchFamily="34" charset="0"/>
                <a:cs typeface="Arial" panose="020B0604020202020204" pitchFamily="34" charset="0"/>
              </a:rPr>
              <a:t>R. </a:t>
            </a:r>
            <a:r>
              <a:rPr lang="en-US" sz="16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parkeri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rickettsioses.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C3H/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HeN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mice were inoculated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i.v.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with 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R. </a:t>
            </a:r>
            <a:r>
              <a:rPr lang="en-US" sz="1600" i="1" dirty="0" err="1">
                <a:latin typeface="Arial" panose="020B0604020202020204" pitchFamily="34" charset="0"/>
                <a:cs typeface="Arial" panose="020B0604020202020204" pitchFamily="34" charset="0"/>
              </a:rPr>
              <a:t>parkeri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WT at a dose indicated from 2 × 10^7 to 4 × 10^8 copies of CS genes per mouse. Mice were monitored daily for weight loss (A) and survival (B). On day 4 p.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., mice inoculated with 3 x 10^ 5 copies of CS genes per mouse or 1 × 10^ 7 copies of CS gene per mouse were euthanized. Tissues were collected.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Rickettsial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load in liver was determined by quantitative real-time PCR (C). CS gene, citrate synthase gene. Each group include 4-10 mice. *, 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&lt;0.05.</a:t>
            </a:r>
          </a:p>
          <a:p>
            <a:pPr algn="just"/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469193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985458"/>
            <a:ext cx="6858000" cy="2471931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72417" y="4164143"/>
            <a:ext cx="6460857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 IFA of </a:t>
            </a:r>
            <a:r>
              <a:rPr lang="en-US" sz="1600" b="1" i="1" dirty="0">
                <a:latin typeface="Arial" panose="020B0604020202020204" pitchFamily="34" charset="0"/>
                <a:cs typeface="Arial" panose="020B0604020202020204" pitchFamily="34" charset="0"/>
              </a:rPr>
              <a:t>R. </a:t>
            </a:r>
            <a:r>
              <a:rPr lang="en-US" sz="16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parkeri</a:t>
            </a:r>
            <a:r>
              <a:rPr lang="en-US" sz="16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WT antigen with sera from mouse immunized with </a:t>
            </a:r>
            <a:r>
              <a:rPr lang="en-US" sz="1600" b="1" i="1" dirty="0">
                <a:latin typeface="Arial" panose="020B0604020202020204" pitchFamily="34" charset="0"/>
                <a:cs typeface="Arial" panose="020B0604020202020204" pitchFamily="34" charset="0"/>
              </a:rPr>
              <a:t>R. </a:t>
            </a:r>
            <a:r>
              <a:rPr lang="en-US" sz="16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parkeri</a:t>
            </a:r>
            <a:r>
              <a:rPr lang="en-US" sz="16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3A2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3H/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HeN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mice were immunized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i.d.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with 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R. </a:t>
            </a:r>
            <a:r>
              <a:rPr lang="en-US" sz="1600" i="1" dirty="0" err="1">
                <a:latin typeface="Arial" panose="020B0604020202020204" pitchFamily="34" charset="0"/>
                <a:cs typeface="Arial" panose="020B0604020202020204" pitchFamily="34" charset="0"/>
              </a:rPr>
              <a:t>parkeri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3A2 at a dose of 1 x 10^3 copies of CS genes per mouse. Sera was collected on day 56 post immunization (A). Sera of mice inoculated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i.d.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with PBS served as controls (B). Each group included 4-10 mice. IFA slides were prepared and processed as described in the Materials and Methods. Slides were examined under an Echo Revolve Microscope equipped for epifluorescence at 20X magnification. </a:t>
            </a:r>
          </a:p>
        </p:txBody>
      </p:sp>
    </p:spTree>
    <p:extLst>
      <p:ext uri="{BB962C8B-B14F-4D97-AF65-F5344CB8AC3E}">
        <p14:creationId xmlns:p14="http://schemas.microsoft.com/office/powerpoint/2010/main" val="21197204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6</TotalTime>
  <Words>246</Words>
  <Application>Microsoft Office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UTMB Healt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ng, Rong</dc:creator>
  <cp:lastModifiedBy>Fang, Rong</cp:lastModifiedBy>
  <cp:revision>10</cp:revision>
  <dcterms:created xsi:type="dcterms:W3CDTF">2021-04-06T19:45:44Z</dcterms:created>
  <dcterms:modified xsi:type="dcterms:W3CDTF">2021-06-09T23:07:06Z</dcterms:modified>
</cp:coreProperties>
</file>